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7456D-664D-48ED-BF0C-978F3F5BBCE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DFAA0F-11A3-41BB-B8C5-5DAC0F371F2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61BAC3-96A6-40B5-A372-BCB572026A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38A94C-CB5B-4D5C-AE6A-EA6853A9DD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1FFDC4-E4DB-4544-895E-582A55D3CB8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5908EF-8151-4FAD-8E6F-5DE9A2B149F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866528-99EB-492A-B003-597EF71D5A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CCB61F-D5A4-4E3C-AD1E-8EC6CA4907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AA581-885A-4A1A-B230-2B7E908499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6A2C35-842E-42F3-9F29-87A7E03393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038D94-EA28-4110-9687-AD70C221449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04862D-FFE4-4819-908A-578DF545EBB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E9EC2D3-9CFA-45D7-B741-B5F2EF37A268}" type="slidenum">
              <a:rPr b="0" lang="ja-JP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442400" y="4122720"/>
            <a:ext cx="1396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Control si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1066680" y="4122720"/>
            <a:ext cx="1981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400" spc="-1" strike="noStrike">
                <a:solidFill>
                  <a:srgbClr val="000000"/>
                </a:solidFill>
                <a:latin typeface="Arial"/>
              </a:rPr>
              <a:t>EGR1 siRN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628560" y="6548400"/>
            <a:ext cx="2863800" cy="189540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2"/>
          <a:stretch/>
        </p:blipFill>
        <p:spPr>
          <a:xfrm>
            <a:off x="3657600" y="6548400"/>
            <a:ext cx="2895480" cy="190980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3"/>
          <a:stretch/>
        </p:blipFill>
        <p:spPr>
          <a:xfrm>
            <a:off x="3657600" y="4465800"/>
            <a:ext cx="2895480" cy="1909440"/>
          </a:xfrm>
          <a:prstGeom prst="rect">
            <a:avLst/>
          </a:prstGeom>
          <a:ln w="0">
            <a:noFill/>
          </a:ln>
        </p:spPr>
      </p:pic>
      <p:pic>
        <p:nvPicPr>
          <p:cNvPr id="46" name="" descr=""/>
          <p:cNvPicPr/>
          <p:nvPr/>
        </p:nvPicPr>
        <p:blipFill>
          <a:blip r:embed="rId4"/>
          <a:stretch/>
        </p:blipFill>
        <p:spPr>
          <a:xfrm>
            <a:off x="609480" y="4465800"/>
            <a:ext cx="2895840" cy="191916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609480" y="4476600"/>
            <a:ext cx="2895840" cy="19051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609480" y="6548400"/>
            <a:ext cx="2895840" cy="19051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3657600" y="4476600"/>
            <a:ext cx="2895480" cy="19051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3657600" y="6548400"/>
            <a:ext cx="2895480" cy="1905120"/>
          </a:xfrm>
          <a:prstGeom prst="rect">
            <a:avLst/>
          </a:prstGeom>
          <a:noFill/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V="1">
            <a:off x="4038480" y="7894440"/>
            <a:ext cx="304920" cy="152280"/>
          </a:xfrm>
          <a:prstGeom prst="line">
            <a:avLst/>
          </a:prstGeom>
          <a:ln w="5724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 flipV="1">
            <a:off x="5105160" y="7360920"/>
            <a:ext cx="152280" cy="228600"/>
          </a:xfrm>
          <a:prstGeom prst="line">
            <a:avLst/>
          </a:prstGeom>
          <a:ln w="57240">
            <a:solidFill>
              <a:srgbClr val="ffffff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4952880" y="8763120"/>
            <a:ext cx="175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Additional data fil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295280" y="714240"/>
            <a:ext cx="2043360" cy="254340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676520" y="1143000"/>
            <a:ext cx="409320" cy="211788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543040" y="2490840"/>
            <a:ext cx="409680" cy="770040"/>
          </a:xfrm>
          <a:prstGeom prst="rect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 flipV="1">
            <a:off x="2743200" y="2282400"/>
            <a:ext cx="1440" cy="2048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720880" y="2282760"/>
            <a:ext cx="478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300320" y="2836800"/>
            <a:ext cx="205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300320" y="2414520"/>
            <a:ext cx="205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300320" y="1989000"/>
            <a:ext cx="20520" cy="180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300320" y="1565280"/>
            <a:ext cx="2052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300320" y="1143000"/>
            <a:ext cx="20520" cy="144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125000" y="3193920"/>
            <a:ext cx="709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019160" y="276876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1019160" y="23464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4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019160" y="19224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6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1019160" y="14968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0.8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019160" y="107460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0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019160" y="650880"/>
            <a:ext cx="1760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1.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709640" y="3344760"/>
            <a:ext cx="3236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Mock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387160" y="3344760"/>
            <a:ext cx="80244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000" spc="-1" strike="noStrike">
                <a:solidFill>
                  <a:srgbClr val="000000"/>
                </a:solidFill>
                <a:latin typeface="Arial"/>
              </a:rPr>
              <a:t>EGR-1 siRN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rot="16200000">
            <a:off x="6840" y="1911600"/>
            <a:ext cx="1603800" cy="18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Relative EGR-1 mRN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47680" y="318960"/>
            <a:ext cx="19872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30400" y="3916440"/>
            <a:ext cx="21708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6" name=""/>
          <p:cNvGrpSpPr/>
          <p:nvPr/>
        </p:nvGrpSpPr>
        <p:grpSpPr>
          <a:xfrm>
            <a:off x="4572000" y="533520"/>
            <a:ext cx="1324080" cy="2439360"/>
            <a:chOff x="4572000" y="533520"/>
            <a:chExt cx="1324080" cy="2439360"/>
          </a:xfrm>
        </p:grpSpPr>
        <p:pic>
          <p:nvPicPr>
            <p:cNvPr id="77" name="" descr=""/>
            <p:cNvPicPr/>
            <p:nvPr/>
          </p:nvPicPr>
          <p:blipFill>
            <a:blip r:embed="rId5"/>
            <a:stretch/>
          </p:blipFill>
          <p:spPr>
            <a:xfrm>
              <a:off x="5058000" y="1666800"/>
              <a:ext cx="830160" cy="13060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8" name=""/>
            <p:cNvSpPr/>
            <p:nvPr/>
          </p:nvSpPr>
          <p:spPr>
            <a:xfrm>
              <a:off x="5058000" y="1666800"/>
              <a:ext cx="838080" cy="1294920"/>
            </a:xfrm>
            <a:prstGeom prst="rect">
              <a:avLst/>
            </a:prstGeom>
            <a:noFill/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H="1">
              <a:off x="4981680" y="227628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H="1">
              <a:off x="4981680" y="202392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H="1">
              <a:off x="4981680" y="192528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H="1">
              <a:off x="4981680" y="183348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H="1">
              <a:off x="4981680" y="2809800"/>
              <a:ext cx="7632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ctr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4648320" y="2176200"/>
              <a:ext cx="380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4648320" y="2709720"/>
              <a:ext cx="380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4572000" y="193356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4572000" y="171432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4572000" y="1819080"/>
              <a:ext cx="4572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4619880" y="1523880"/>
              <a:ext cx="3808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spcBef>
                  <a:spcPts val="499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800" spc="-1" strike="noStrike">
                  <a:solidFill>
                    <a:srgbClr val="000000"/>
                  </a:solidFill>
                  <a:latin typeface="Arial"/>
                </a:rPr>
                <a:t>(bp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rot="16200000">
              <a:off x="4735440" y="1027080"/>
              <a:ext cx="1066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900" spc="-1" strike="noStrike">
                  <a:solidFill>
                    <a:srgbClr val="000000"/>
                  </a:solidFill>
                  <a:latin typeface="Arial"/>
                </a:rPr>
                <a:t>100bp ladder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rot="16200000">
              <a:off x="5078520" y="989280"/>
              <a:ext cx="11426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56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ja-JP" sz="900" spc="-1" strike="noStrike">
                  <a:solidFill>
                    <a:srgbClr val="000000"/>
                  </a:solidFill>
                  <a:latin typeface="Arial"/>
                </a:rPr>
                <a:t>sonicated DNA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92" name=""/>
          <p:cNvSpPr/>
          <p:nvPr/>
        </p:nvSpPr>
        <p:spPr>
          <a:xfrm>
            <a:off x="4290840" y="318960"/>
            <a:ext cx="198720" cy="426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9-03T07:27:20Z</dcterms:created>
  <dc:creator>Kubosaki</dc:creator>
  <dc:description/>
  <dc:language>en-US</dc:language>
  <cp:lastModifiedBy>Kubosaki</cp:lastModifiedBy>
  <cp:lastPrinted>2008-09-03T09:35:14Z</cp:lastPrinted>
  <dcterms:modified xsi:type="dcterms:W3CDTF">2009-02-05T05:53:43Z</dcterms:modified>
  <cp:revision>6</cp:revision>
  <dc:subject/>
  <dc:title>PowerPoint プレゼンテーション</dc:title>
</cp:coreProperties>
</file>